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3" autoAdjust="0"/>
    <p:restoredTop sz="94660"/>
  </p:normalViewPr>
  <p:slideViewPr>
    <p:cSldViewPr snapToGrid="0">
      <p:cViewPr varScale="1">
        <p:scale>
          <a:sx n="86" d="100"/>
          <a:sy n="86" d="100"/>
        </p:scale>
        <p:origin x="42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47C496-049D-4D79-8907-4689498C40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1DEB69E-54BB-405E-B47D-908E1B846D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B0ED816-347B-4EE1-9E0F-1D95F2B29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0030-7894-48F1-ACC3-17AE77D88BD2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8C5F19-A268-4B92-B58C-4EE8A2FF0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B8253B-FAC1-44DE-9C12-9454C1B77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AB54E-93B7-4A0A-B6FC-A08AA39C6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15500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241A8A-7533-4585-B24E-4EBC7D9CF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C17E447-304D-4810-99DF-B8FE50746B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FA2932-F279-40B6-A7FC-A7813A87D0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0030-7894-48F1-ACC3-17AE77D88BD2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910F74-CA8C-428C-95F0-B096C3891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DF014A-6264-4D11-B622-546C12FE8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AB54E-93B7-4A0A-B6FC-A08AA39C6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3604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AC6E857-C872-4096-9A38-3F35F54345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0724E68-D55B-45BE-8133-C5F2443171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7221A7-A76C-4A8A-916D-268E0FEE74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0030-7894-48F1-ACC3-17AE77D88BD2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AE4276-4199-4C44-B6C6-036008190A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D34F79-308A-46EE-A2A2-81E7228356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AB54E-93B7-4A0A-B6FC-A08AA39C6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6537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F23352-138A-4035-80D4-49F7B603DF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4F86811-EFC7-4368-AE42-A806C77D33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AA2BD8A-D1D8-4835-9EA2-E478380FE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0030-7894-48F1-ACC3-17AE77D88BD2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1CF70A0-5B24-4A21-BA71-9F4900866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86FC49-E1F0-466E-9F47-00CF6B563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AB54E-93B7-4A0A-B6FC-A08AA39C6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406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986958-316F-4F0D-80D1-0F6C2A9DBC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9CA5AB8-089E-4DBF-9EB1-AC70C32DCC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056E4E-0A43-4221-9062-33A4BA98D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0030-7894-48F1-ACC3-17AE77D88BD2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962C620-7064-496B-9158-9FAB4DC02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B57C4A-A2D1-42D7-9642-008820FE5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AB54E-93B7-4A0A-B6FC-A08AA39C6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9328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5376C7-52C9-48DF-AA1D-0B22DA2226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5494329-D0EE-499E-95F7-805F5E9272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52D04C5-9843-4E8E-B69F-7890C300B3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5E92881-C92F-4547-A8B8-6B00B20A03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0030-7894-48F1-ACC3-17AE77D88BD2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9AAB08C-F440-4DCE-B92E-09D7664BE7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16CA8AB-CD96-434D-A144-9F4FE6C93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AB54E-93B7-4A0A-B6FC-A08AA39C6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1803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C41EDA-6581-4403-8A29-49B2338505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F7A35AB-AACA-49B2-A9BC-CAEC460EB3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B3DEAD3-82BA-4BD4-851D-10C08DAA4D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7E1B599-15FE-4FC1-A567-62C4372938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ABB5E68-B76E-4FCC-9B56-B87DC5884D5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F21A511-77A2-465E-8736-A89327ACD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0030-7894-48F1-ACC3-17AE77D88BD2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78AC4F1-3FDA-4BE2-8862-53813FE4B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A9674C8-421F-475F-9EB9-57D0A7E5B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AB54E-93B7-4A0A-B6FC-A08AA39C6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4734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450FFE-770B-45A7-B693-0D3498F0E9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51A9FD6-1FD5-4267-BB59-A5B2396C3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0030-7894-48F1-ACC3-17AE77D88BD2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948C49A-E72A-462F-9BDB-BFD34A937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C53889B-9118-4C5F-BCDA-D60E9AB6F0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AB54E-93B7-4A0A-B6FC-A08AA39C6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2649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58D77B2-7118-47BF-9561-2FC04F1C4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0030-7894-48F1-ACC3-17AE77D88BD2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814647C-21DD-4EF9-B4B4-E2C108F47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7D243D5-9AC1-4731-B96C-A8A2CCDFE9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AB54E-93B7-4A0A-B6FC-A08AA39C6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40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170E14-C33C-4D72-A5DC-505EDCE999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DAF4DE8-7D3C-4F23-A968-9150995D90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8476CD7-08BA-40E1-B3B0-7BACE37565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1ECAE88-C8EA-41AB-9315-4353D3995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0030-7894-48F1-ACC3-17AE77D88BD2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CA91F67-8D6A-45AC-B2FA-913E09D86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C8F19DB-CDED-41DB-8831-AAF7FB3CE5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AB54E-93B7-4A0A-B6FC-A08AA39C6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7204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2271D5-4475-4D4E-8D0D-CC246BDFA6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E13DAF0-F2E7-4D40-8201-D09B8DBA10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9829E71-6435-4533-B4DA-1715976DFF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D4A7798-9103-44B1-9373-160EE780CB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0030-7894-48F1-ACC3-17AE77D88BD2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5AF2E99-8122-4805-988E-5003285D09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E1629A2-5A7E-4AFB-87A3-CD0FEE9DD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AB54E-93B7-4A0A-B6FC-A08AA39C6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6583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53F6DDA-1BF5-41A7-84FC-A7F429823C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8C61894-8AA2-41B1-BD62-5F2EA09FF8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846658-E3F9-44FD-9D08-D575E62ADA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40030-7894-48F1-ACC3-17AE77D88BD2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466D6D4-0ED5-450C-93F0-32059F76D4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629701-6EB5-409C-9463-4F0054EC62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AAB54E-93B7-4A0A-B6FC-A08AA39C6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862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DC8390-A399-4BA6-8A26-7C2A40DC62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407575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 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zh-CN" sz="20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orrelation between Treg frequency and levels of maternal HBsAg and </a:t>
            </a:r>
            <a:r>
              <a:rPr lang="en-GB" altLang="zh-CN" sz="20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HBeAg</a:t>
            </a:r>
            <a:r>
              <a:rPr lang="en-GB" altLang="zh-CN" sz="20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in intervention mothers at 15‒18 weeks postpartum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B9BEBC32-749B-4D28-84B4-8681EDFFBC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7840" y="2609051"/>
            <a:ext cx="4490971" cy="290592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63E9A712-CB13-4378-BBA6-FA8C1CA09D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54747" y="2609052"/>
            <a:ext cx="4393735" cy="282734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E9064C09-9EC0-43A8-99C1-AF4876066F5B}"/>
              </a:ext>
            </a:extLst>
          </p:cNvPr>
          <p:cNvSpPr txBox="1"/>
          <p:nvPr/>
        </p:nvSpPr>
        <p:spPr>
          <a:xfrm>
            <a:off x="932583" y="2050200"/>
            <a:ext cx="7033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A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6666D21-4449-4588-881A-8C7E005E260A}"/>
              </a:ext>
            </a:extLst>
          </p:cNvPr>
          <p:cNvSpPr txBox="1"/>
          <p:nvPr/>
        </p:nvSpPr>
        <p:spPr>
          <a:xfrm>
            <a:off x="6692826" y="2072395"/>
            <a:ext cx="7033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B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03100327-FF50-9576-5214-9587FC20E842}"/>
              </a:ext>
            </a:extLst>
          </p:cNvPr>
          <p:cNvSpPr txBox="1"/>
          <p:nvPr/>
        </p:nvSpPr>
        <p:spPr>
          <a:xfrm>
            <a:off x="1189940" y="5514974"/>
            <a:ext cx="945438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S</a:t>
            </a:r>
            <a:r>
              <a:rPr lang="en-GB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upplementary Fig.1A  Correlation of maternal HB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</a:t>
            </a:r>
            <a:r>
              <a:rPr lang="en-GB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g levels with Treg frequency in AVI group at 15‒18 weeks after delivery.(</a:t>
            </a:r>
            <a:r>
              <a:rPr lang="en-GB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</a:t>
            </a:r>
            <a:r>
              <a:rPr lang="en-GB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= 0.247, r = 0.307). </a:t>
            </a:r>
            <a:r>
              <a:rPr lang="en-GB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 represents the correlation coefficient.</a:t>
            </a:r>
            <a:r>
              <a:rPr lang="en-GB" altLang="zh-CN" sz="18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endParaRPr lang="en-GB" altLang="zh-CN" sz="18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等线" panose="02010600030101010101" pitchFamily="2" charset="-122"/>
            </a:endParaRPr>
          </a:p>
          <a:p>
            <a:r>
              <a:rPr lang="en-GB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S</a:t>
            </a:r>
            <a:r>
              <a:rPr lang="en-GB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upplementary Fig.1B  Correlation of maternal HB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e</a:t>
            </a:r>
            <a:r>
              <a:rPr lang="en-GB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g levels with Treg frequency in AVI group at 15‒18 weeks after delivery. (</a:t>
            </a:r>
            <a:r>
              <a:rPr lang="en-GB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</a:t>
            </a:r>
            <a:r>
              <a:rPr lang="en-GB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= 0.034, r = 0.532). </a:t>
            </a:r>
            <a:r>
              <a:rPr lang="en-GB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 represents the correlation coefficient.</a:t>
            </a:r>
            <a:r>
              <a:rPr lang="en-GB" altLang="zh-CN" sz="18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49278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</TotalTime>
  <Words>97</Words>
  <Application>Microsoft Office PowerPoint</Application>
  <PresentationFormat>宽屏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Supplementary Figures  Correlation between Treg frequency and levels of maternal HBsAg and HBeAg in intervention mothers at 15‒18 weeks postpartum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zhihualiu@126.com</dc:creator>
  <cp:lastModifiedBy>13046</cp:lastModifiedBy>
  <cp:revision>5</cp:revision>
  <dcterms:created xsi:type="dcterms:W3CDTF">2022-01-05T15:50:52Z</dcterms:created>
  <dcterms:modified xsi:type="dcterms:W3CDTF">2023-03-02T04:46:34Z</dcterms:modified>
</cp:coreProperties>
</file>